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41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B13A89-1EA1-92F2-8AA2-78408AFC86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41EA5A-EB4F-1797-A73B-87258FB610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751ACA-AD1A-3E6F-FFA9-3170AA9BBA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216908-7217-DCD8-2A78-CB58A490CB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061263-A388-E0DF-EB3C-EFD3BC9AF4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748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603768-8808-8E12-F9B8-AE194AB52E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2DAC13-1DD7-3330-CF76-19A247ADE2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0479D2-A2E7-F582-E60B-30E82239A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852A71-0B73-3991-AB66-047173A408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9CF39C-7F78-002E-DF0E-BA6662E1BA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363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D0151C3-82CD-EAD0-9956-24A7CC366F2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58BF45-AAB3-B1B8-028B-6CB9E68EA6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818C1F-0155-94C0-67C6-E2A6E2033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18F44A-F4C0-57D6-0939-C6F31BCF9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9283EB-DB7A-EFD8-3276-801C7B69FD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80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92D243-B571-7AAC-1FDE-C41B01CB82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72628F-80E9-C7A5-6384-467D34CF62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94C221-199F-FE56-91F6-429FF12AEA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A4B855-71A0-C3F3-FDF2-9A8D94D4E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2A6982-E599-9278-6D31-06E29CC579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347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EF25FF-A719-383C-3DDF-7FAB4DE127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8C19C9-761E-7828-FE21-5CC7855247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4E2B0F-0886-6525-E730-CDC2E9FAB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378C3F-CC58-09F9-B929-C87ACE0DD4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F80EAB-A905-4E39-7CDC-0957BAE19F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769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6A1037-17F0-29E9-A356-A3D18922C8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15F4EF-180B-497E-AA49-22E9FCDACE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ED0F26-C6F4-E1C1-BC20-E17DF87885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17C6DA-1A6D-C592-67BE-4316773C03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680587-E822-58C2-CF42-828C8F0F58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2E8950-864F-B9E9-D955-1927A08B39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606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C310BB-FC59-2ECC-D16C-CA9C8B32B8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B5CDF1-28E2-324A-8D5A-66B1F55E81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F5FBBB-FDFD-87D4-6069-0087CBEBD8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6F8DCF0-DCD7-0861-FB55-AEA976A1EE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7D37029-C5F6-9265-7576-3A6059909D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7AC9AAA-5CAB-62D1-861A-EC5C37F135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43DDB17-C76B-9CB8-F08A-C5F9A627A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B928B5D-1A46-69AD-8FE6-C5E1436CBA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742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55E5C8-7BCC-2F43-877E-E7D65B201E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6C962D-0537-40B9-971F-3900AF5DF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14B7FFA-AAC6-F8CA-6742-F0B36FEC63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E35555A-F0BB-BA71-2685-05A129BCB9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957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EC279D5-DEE3-28F4-CB23-431F5C4BD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ED0875-4997-AB5E-7559-E8F90018A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ABCB04F-CBA2-1E51-EE9D-A9D0924E2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805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6DD609-4F73-801A-613F-7BB0157F18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966015-B272-66BC-A8D8-8B4ADE8685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A891CE-AF73-2A44-A44E-7B2A600D99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BD3D20-BB90-7774-DD93-A3026198D5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6D9157-0861-F143-F3B9-6FB344D6A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5B78E8-E8CD-E647-BB6F-2041DE9C3D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059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DB2DFA-4B99-B2D0-CC52-8EB5EA6BC1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76DC337-289D-9EAA-427E-09AF1CF745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4B8F27-F7FB-5C18-875F-9C6A65EFF3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CC1027-AABC-9EE7-71CD-6B2540A36B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B01694-4305-B654-D76B-A323EEFD69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74410B-3152-B891-0E65-64524021F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82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8964E5E-1B8B-ADD9-825F-BF7DC48219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36D9F2-7D66-F471-4ACB-6D3B47F5F6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266093-8E15-8A53-2E23-85AB5D37F8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6F236F-7108-EE34-16AA-3C23D69032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5FC914-40A0-C066-82FB-FB08036C84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259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947E8A51-A696-01CB-8D3B-7299593763D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4143287"/>
              </p:ext>
            </p:extLst>
          </p:nvPr>
        </p:nvGraphicFramePr>
        <p:xfrm>
          <a:off x="159804" y="-85725"/>
          <a:ext cx="7050621" cy="52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6880166" imgH="5170489" progId="Prism10.Document">
                  <p:embed/>
                </p:oleObj>
              </mc:Choice>
              <mc:Fallback>
                <p:oleObj name="Prism 10" r:id="rId2" imgW="6880166" imgH="5170489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947E8A51-A696-01CB-8D3B-7299593763D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59804" y="-85725"/>
                        <a:ext cx="7050621" cy="5298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4C682C0B-B287-BD90-6E41-ED033CE584A0}"/>
              </a:ext>
            </a:extLst>
          </p:cNvPr>
          <p:cNvSpPr txBox="1"/>
          <p:nvPr/>
        </p:nvSpPr>
        <p:spPr>
          <a:xfrm>
            <a:off x="364634" y="5434987"/>
            <a:ext cx="109653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2</a:t>
            </a:r>
            <a:r>
              <a:rPr lang="en-US" dirty="0"/>
              <a:t>. </a:t>
            </a:r>
            <a:r>
              <a:rPr lang="en-US" i="1" dirty="0"/>
              <a:t>Overall immune cell abundances</a:t>
            </a:r>
            <a:r>
              <a:rPr lang="en-US" dirty="0"/>
              <a:t>. Immune cell relative abundances measured by flow cytometry. Graphs are proportion of total CD45</a:t>
            </a:r>
            <a:r>
              <a:rPr lang="en-US" baseline="30000" dirty="0"/>
              <a:t>+</a:t>
            </a:r>
            <a:r>
              <a:rPr lang="en-US" dirty="0"/>
              <a:t> cells. n = 10 per group. </a:t>
            </a:r>
            <a:r>
              <a:rPr lang="en-US" dirty="0" err="1"/>
              <a:t>Omaveloxolone</a:t>
            </a:r>
            <a:r>
              <a:rPr lang="en-US" dirty="0"/>
              <a:t> treatment group n = 5.</a:t>
            </a:r>
          </a:p>
        </p:txBody>
      </p:sp>
    </p:spTree>
    <p:extLst>
      <p:ext uri="{BB962C8B-B14F-4D97-AF65-F5344CB8AC3E}">
        <p14:creationId xmlns:p14="http://schemas.microsoft.com/office/powerpoint/2010/main" val="38726842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3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Occhiuto, Christopher</dc:creator>
  <cp:lastModifiedBy>Occhiuto, Christopher</cp:lastModifiedBy>
  <cp:revision>8</cp:revision>
  <dcterms:created xsi:type="dcterms:W3CDTF">2025-09-22T19:27:39Z</dcterms:created>
  <dcterms:modified xsi:type="dcterms:W3CDTF">2025-09-22T19:39:49Z</dcterms:modified>
</cp:coreProperties>
</file>